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99300" cy="10234613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epnutím lze upravit styl předlohy podnadpisů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747F2-DBCA-4A5D-9E26-1FB6CA72058D}" type="datetimeFigureOut">
              <a:rPr lang="cs-CZ" smtClean="0"/>
              <a:pPr/>
              <a:t>19.8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C5AD9-1595-4244-9282-0CDE7FE28DB9}" type="slidenum">
              <a:rPr lang="cs-CZ" smtClean="0"/>
              <a:pPr/>
              <a:t>‹#›</a:t>
            </a:fld>
            <a:endParaRPr lang="cs-C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ovéPole 33"/>
          <p:cNvSpPr txBox="1"/>
          <p:nvPr/>
        </p:nvSpPr>
        <p:spPr>
          <a:xfrm>
            <a:off x="476672" y="7452320"/>
            <a:ext cx="6048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b="1" smtClean="0"/>
              <a:t>Figure </a:t>
            </a:r>
            <a:r>
              <a:rPr lang="cs-CZ" sz="1200" b="1" smtClean="0"/>
              <a:t>S4</a:t>
            </a:r>
            <a:endParaRPr lang="cs-CZ" sz="1200"/>
          </a:p>
        </p:txBody>
      </p:sp>
      <p:sp>
        <p:nvSpPr>
          <p:cNvPr id="18" name="TextovéPole 17"/>
          <p:cNvSpPr txBox="1"/>
          <p:nvPr/>
        </p:nvSpPr>
        <p:spPr>
          <a:xfrm>
            <a:off x="4005064" y="5076056"/>
            <a:ext cx="149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smtClean="0"/>
              <a:t>JURKAT + imatinib</a:t>
            </a:r>
            <a:endParaRPr lang="cs-CZ" sz="1400"/>
          </a:p>
        </p:txBody>
      </p:sp>
      <p:grpSp>
        <p:nvGrpSpPr>
          <p:cNvPr id="28" name="Skupina 27"/>
          <p:cNvGrpSpPr/>
          <p:nvPr/>
        </p:nvGrpSpPr>
        <p:grpSpPr>
          <a:xfrm>
            <a:off x="476672" y="611560"/>
            <a:ext cx="3057754" cy="2187469"/>
            <a:chOff x="476672" y="683568"/>
            <a:chExt cx="3057754" cy="2187469"/>
          </a:xfrm>
        </p:grpSpPr>
        <p:sp>
          <p:nvSpPr>
            <p:cNvPr id="11" name="TextovéPole 10"/>
            <p:cNvSpPr txBox="1"/>
            <p:nvPr/>
          </p:nvSpPr>
          <p:spPr>
            <a:xfrm>
              <a:off x="1196752" y="683568"/>
              <a:ext cx="17635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smtClean="0"/>
                <a:t>JURL-MK1 + dasatinib</a:t>
              </a:r>
              <a:endParaRPr lang="cs-CZ" sz="1400"/>
            </a:p>
          </p:txBody>
        </p:sp>
        <p:pic>
          <p:nvPicPr>
            <p:cNvPr id="21" name="Obrázek 20" descr="FACS JURL Das.wm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76672" y="899591"/>
              <a:ext cx="3057754" cy="1971446"/>
            </a:xfrm>
            <a:prstGeom prst="rect">
              <a:avLst/>
            </a:prstGeom>
          </p:spPr>
        </p:pic>
      </p:grpSp>
      <p:grpSp>
        <p:nvGrpSpPr>
          <p:cNvPr id="29" name="Skupina 28"/>
          <p:cNvGrpSpPr/>
          <p:nvPr/>
        </p:nvGrpSpPr>
        <p:grpSpPr>
          <a:xfrm>
            <a:off x="3356992" y="611560"/>
            <a:ext cx="3057754" cy="2187469"/>
            <a:chOff x="3356992" y="683568"/>
            <a:chExt cx="3057754" cy="2187469"/>
          </a:xfrm>
        </p:grpSpPr>
        <p:sp>
          <p:nvSpPr>
            <p:cNvPr id="12" name="TextovéPole 11"/>
            <p:cNvSpPr txBox="1"/>
            <p:nvPr/>
          </p:nvSpPr>
          <p:spPr>
            <a:xfrm>
              <a:off x="4005064" y="683568"/>
              <a:ext cx="16962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smtClean="0"/>
                <a:t>JURL-MK1 + imatinib</a:t>
              </a:r>
              <a:endParaRPr lang="cs-CZ" sz="1400"/>
            </a:p>
          </p:txBody>
        </p:sp>
        <p:pic>
          <p:nvPicPr>
            <p:cNvPr id="22" name="Obrázek 21" descr="FACS JURL imat.wm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356992" y="899591"/>
              <a:ext cx="3057754" cy="1971446"/>
            </a:xfrm>
            <a:prstGeom prst="rect">
              <a:avLst/>
            </a:prstGeom>
          </p:spPr>
        </p:pic>
      </p:grpSp>
      <p:grpSp>
        <p:nvGrpSpPr>
          <p:cNvPr id="30" name="Skupina 29"/>
          <p:cNvGrpSpPr/>
          <p:nvPr/>
        </p:nvGrpSpPr>
        <p:grpSpPr>
          <a:xfrm>
            <a:off x="476672" y="2843808"/>
            <a:ext cx="3057754" cy="2187470"/>
            <a:chOff x="476672" y="3131840"/>
            <a:chExt cx="3057754" cy="2187470"/>
          </a:xfrm>
        </p:grpSpPr>
        <p:sp>
          <p:nvSpPr>
            <p:cNvPr id="14" name="TextovéPole 13"/>
            <p:cNvSpPr txBox="1"/>
            <p:nvPr/>
          </p:nvSpPr>
          <p:spPr>
            <a:xfrm>
              <a:off x="1196752" y="3131840"/>
              <a:ext cx="16721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smtClean="0"/>
                <a:t>MOLM-7 + dasatinib</a:t>
              </a:r>
              <a:endParaRPr lang="cs-CZ" sz="1400"/>
            </a:p>
          </p:txBody>
        </p:sp>
        <p:pic>
          <p:nvPicPr>
            <p:cNvPr id="24" name="Obrázek 23" descr="FACS MOLM Das.wm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76672" y="3347864"/>
              <a:ext cx="3057754" cy="1971446"/>
            </a:xfrm>
            <a:prstGeom prst="rect">
              <a:avLst/>
            </a:prstGeom>
          </p:spPr>
        </p:pic>
      </p:grpSp>
      <p:grpSp>
        <p:nvGrpSpPr>
          <p:cNvPr id="31" name="Skupina 30"/>
          <p:cNvGrpSpPr/>
          <p:nvPr/>
        </p:nvGrpSpPr>
        <p:grpSpPr>
          <a:xfrm>
            <a:off x="3356992" y="2843808"/>
            <a:ext cx="3057754" cy="2187470"/>
            <a:chOff x="3356992" y="3131840"/>
            <a:chExt cx="3057754" cy="2187470"/>
          </a:xfrm>
        </p:grpSpPr>
        <p:sp>
          <p:nvSpPr>
            <p:cNvPr id="16" name="TextovéPole 15"/>
            <p:cNvSpPr txBox="1"/>
            <p:nvPr/>
          </p:nvSpPr>
          <p:spPr>
            <a:xfrm>
              <a:off x="4005064" y="3131840"/>
              <a:ext cx="16048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smtClean="0"/>
                <a:t>MOLM-7 + imatinib</a:t>
              </a:r>
              <a:endParaRPr lang="cs-CZ" sz="1400"/>
            </a:p>
          </p:txBody>
        </p:sp>
        <p:pic>
          <p:nvPicPr>
            <p:cNvPr id="25" name="Obrázek 24" descr="FACS MOLM imat.wm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356992" y="3347864"/>
              <a:ext cx="3057754" cy="1971446"/>
            </a:xfrm>
            <a:prstGeom prst="rect">
              <a:avLst/>
            </a:prstGeom>
          </p:spPr>
        </p:pic>
      </p:grpSp>
      <p:grpSp>
        <p:nvGrpSpPr>
          <p:cNvPr id="33" name="Skupina 32"/>
          <p:cNvGrpSpPr/>
          <p:nvPr/>
        </p:nvGrpSpPr>
        <p:grpSpPr>
          <a:xfrm>
            <a:off x="476672" y="5076056"/>
            <a:ext cx="3057754" cy="2187470"/>
            <a:chOff x="3356992" y="5652120"/>
            <a:chExt cx="3057754" cy="2187470"/>
          </a:xfrm>
        </p:grpSpPr>
        <p:sp>
          <p:nvSpPr>
            <p:cNvPr id="20" name="TextovéPole 19"/>
            <p:cNvSpPr txBox="1"/>
            <p:nvPr/>
          </p:nvSpPr>
          <p:spPr>
            <a:xfrm>
              <a:off x="4005064" y="5652120"/>
              <a:ext cx="12329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smtClean="0"/>
                <a:t>HEL + imatinib</a:t>
              </a:r>
              <a:endParaRPr lang="cs-CZ" sz="1400"/>
            </a:p>
          </p:txBody>
        </p:sp>
        <p:pic>
          <p:nvPicPr>
            <p:cNvPr id="27" name="Obrázek 26" descr="FACS HEL imat.wm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356992" y="5868144"/>
              <a:ext cx="3057754" cy="1971446"/>
            </a:xfrm>
            <a:prstGeom prst="rect">
              <a:avLst/>
            </a:prstGeom>
          </p:spPr>
        </p:pic>
      </p:grpSp>
      <p:pic>
        <p:nvPicPr>
          <p:cNvPr id="26" name="Obrázek 25" descr="FACS JURKAT imat.wm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356992" y="5292080"/>
            <a:ext cx="3096344" cy="199632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20</Words>
  <Application>Microsoft Office PowerPoint</Application>
  <PresentationFormat>Předvádění na obrazovce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ady Office</vt:lpstr>
      <vt:lpstr>Snímek 1</vt:lpstr>
    </vt:vector>
  </TitlesOfParts>
  <Company>uhk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nímek 1</dc:title>
  <dc:creator>kuzelova</dc:creator>
  <cp:lastModifiedBy>kuzelova</cp:lastModifiedBy>
  <cp:revision>18</cp:revision>
  <dcterms:created xsi:type="dcterms:W3CDTF">2014-03-06T08:49:56Z</dcterms:created>
  <dcterms:modified xsi:type="dcterms:W3CDTF">2014-08-19T08:00:14Z</dcterms:modified>
</cp:coreProperties>
</file>